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notesSlides/notesSlide15.xml" ContentType="application/vnd.openxmlformats-officedocument.presentationml.notesSlide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slideLayouts/slideLayout10.xml" ContentType="application/vnd.openxmlformats-officedocument.presentationml.slideLayout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0.xml" ContentType="application/vnd.openxmlformats-officedocument.presentationml.notes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Default Extension="png" ContentType="image/png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sldIdLst>
    <p:sldId id="261" r:id="rId2"/>
    <p:sldId id="257" r:id="rId3"/>
    <p:sldId id="263" r:id="rId4"/>
    <p:sldId id="282" r:id="rId5"/>
    <p:sldId id="270" r:id="rId6"/>
    <p:sldId id="272" r:id="rId7"/>
    <p:sldId id="273" r:id="rId8"/>
    <p:sldId id="274" r:id="rId9"/>
    <p:sldId id="275" r:id="rId10"/>
    <p:sldId id="276" r:id="rId11"/>
    <p:sldId id="277" r:id="rId12"/>
    <p:sldId id="278" r:id="rId13"/>
    <p:sldId id="279" r:id="rId14"/>
    <p:sldId id="280" r:id="rId15"/>
    <p:sldId id="281" r:id="rId16"/>
  </p:sldIdLst>
  <p:sldSz cx="12192000" cy="6858000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3" autoAdjust="0"/>
    <p:restoredTop sz="83613" autoAdjust="0"/>
  </p:normalViewPr>
  <p:slideViewPr>
    <p:cSldViewPr snapToGrid="0">
      <p:cViewPr varScale="1">
        <p:scale>
          <a:sx n="68" d="100"/>
          <a:sy n="68" d="100"/>
        </p:scale>
        <p:origin x="-372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st Bilgi Yer Tutucusu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3" name="Veri Yer Tutucusu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0EB3F-3475-4401-9E09-7749E7A90162}" type="datetimeFigureOut">
              <a:rPr lang="tr-TR" smtClean="0"/>
              <a:pPr/>
              <a:t>8.01.2024</a:t>
            </a:fld>
            <a:endParaRPr lang="tr-TR"/>
          </a:p>
        </p:txBody>
      </p:sp>
      <p:sp>
        <p:nvSpPr>
          <p:cNvPr id="4" name="Slayt Resmi Yer Tutucus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tr-TR"/>
          </a:p>
        </p:txBody>
      </p:sp>
      <p:sp>
        <p:nvSpPr>
          <p:cNvPr id="5" name="Not Yer Tutucusu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6" name="Alt Bilgi Yer Tutucusu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7" name="Slayt Numarası Yer Tutucus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66FAFE-F996-4C83-9839-F2FB59A8BB69}" type="slidenum">
              <a:rPr lang="tr-TR" smtClean="0"/>
              <a:pPr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19259956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tr-T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tr-T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tr-T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tr-T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ligonucleotid’s</a:t>
            </a:r>
            <a:r>
              <a:rPr lang="tr-T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tr-T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tr-T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injection</a:t>
            </a:r>
            <a:endParaRPr lang="tr-T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66FAFE-F996-4C83-9839-F2FB59A8BB69}" type="slidenum">
              <a:rPr lang="tr-TR" smtClean="0"/>
              <a:pPr/>
              <a:t>1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378449960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15000"/>
              </a:lnSpc>
              <a:spcAft>
                <a:spcPts val="120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Supplementary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Figure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8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of different tissues in the group injected with 0.9% saline.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A.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of striatum tissue,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B.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of hippocampus tissue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and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C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of </a:t>
            </a:r>
            <a:r>
              <a:rPr lang="tr-TR" sz="1800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cerebellum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tissue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.</a:t>
            </a:r>
          </a:p>
          <a:p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70AE13-12C4-4A49-84EF-FB392349FDC1}" type="slidenum">
              <a:rPr lang="tr-TR" smtClean="0"/>
              <a:pPr/>
              <a:t>10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169606882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15000"/>
              </a:lnSpc>
              <a:spcAft>
                <a:spcPts val="120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Supplementary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Figure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9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in female samples of the 500 mg/kg VPA group.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A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in the prefrontal cortex,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B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in the striatum cortex,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C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in the hippocampus,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D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in the cerebellum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.</a:t>
            </a:r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70AE13-12C4-4A49-84EF-FB392349FDC1}" type="slidenum">
              <a:rPr lang="tr-TR" smtClean="0"/>
              <a:pPr/>
              <a:t>11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1727034632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15000"/>
              </a:lnSpc>
              <a:spcAft>
                <a:spcPts val="120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Supplementary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Figure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10.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monstration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t staining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ages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in different groups and tissues.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A.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Demonstration of changes in the striatum in the saline group,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B.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Demonstration of changes in the hippocampus in the saline group,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C.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Demonstration of changes in the striatum in the 500 mg/kg VPA group,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D.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Demonstration of changes in the hippocampus in the 500 mg/kg VPA group.</a:t>
            </a:r>
            <a:endParaRPr lang="tr-TR" sz="1800" dirty="0">
              <a:solidFill>
                <a:srgbClr val="000000"/>
              </a:solidFill>
              <a:effectLst/>
              <a:latin typeface="Calibri Light" panose="020F0302020204030204" pitchFamily="34" charset="0"/>
              <a:ea typeface="Times New Roman" panose="02020603050405020304" pitchFamily="18" charset="0"/>
            </a:endParaRPr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70AE13-12C4-4A49-84EF-FB392349FDC1}" type="slidenum">
              <a:rPr lang="tr-TR" smtClean="0"/>
              <a:pPr/>
              <a:t>12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1689051941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15000"/>
              </a:lnSpc>
              <a:spcAft>
                <a:spcPts val="120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Supplementary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Figure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11.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Demonstration of the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and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t staining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ages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in groups injected with 500 mg/kg VPA.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A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in the hippocampus in groups injected with 500 mg/kg VPA.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B.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t staining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in the striatum in groups injected with 500 mg/kg VPA</a:t>
            </a:r>
            <a:endParaRPr lang="tr-TR" sz="1800" dirty="0">
              <a:solidFill>
                <a:srgbClr val="000000"/>
              </a:solidFill>
              <a:effectLst/>
              <a:latin typeface="Calibri Light" panose="020F0302020204030204" pitchFamily="34" charset="0"/>
              <a:ea typeface="Times New Roman" panose="02020603050405020304" pitchFamily="18" charset="0"/>
            </a:endParaRPr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70AE13-12C4-4A49-84EF-FB392349FDC1}" type="slidenum">
              <a:rPr lang="tr-TR" smtClean="0"/>
              <a:pPr/>
              <a:t>13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35020059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15000"/>
              </a:lnSpc>
              <a:spcAft>
                <a:spcPts val="120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Supplementary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Figure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12.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monstration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t staining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ages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in hippocampus and striatum tissues in different animals in the 400 mg/kg VPA injected group</a:t>
            </a:r>
            <a:endParaRPr lang="tr-TR" sz="1800" dirty="0">
              <a:solidFill>
                <a:srgbClr val="000000"/>
              </a:solidFill>
              <a:effectLst/>
              <a:latin typeface="Calibri Light" panose="020F0302020204030204" pitchFamily="34" charset="0"/>
              <a:ea typeface="Times New Roman" panose="02020603050405020304" pitchFamily="18" charset="0"/>
            </a:endParaRPr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70AE13-12C4-4A49-84EF-FB392349FDC1}" type="slidenum">
              <a:rPr lang="tr-TR" smtClean="0"/>
              <a:pPr/>
              <a:t>14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3909022334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15000"/>
              </a:lnSpc>
              <a:spcAft>
                <a:spcPts val="120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Supplementary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Figure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13.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monstration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t staining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ages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in </a:t>
            </a:r>
            <a:r>
              <a:rPr lang="tr-TR" sz="1800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the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hippocampus and striatum tissues in different animals in the 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3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00 mg/kg VPA injected group with fluorescent staining.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A.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Demonstration of changes in the striatum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,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B.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Demonstration of changes in the hippocampus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.</a:t>
            </a:r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70AE13-12C4-4A49-84EF-FB392349FDC1}" type="slidenum">
              <a:rPr lang="tr-TR" smtClean="0"/>
              <a:pPr/>
              <a:t>15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24222374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tr-TR" b="1" dirty="0" err="1"/>
              <a:t>Supplementary</a:t>
            </a:r>
            <a:r>
              <a:rPr lang="tr-TR" b="1" dirty="0"/>
              <a:t> </a:t>
            </a:r>
            <a:r>
              <a:rPr lang="tr-TR" b="1" dirty="0" err="1"/>
              <a:t>Table</a:t>
            </a:r>
            <a:r>
              <a:rPr lang="tr-TR" b="1" dirty="0"/>
              <a:t> 2: </a:t>
            </a:r>
            <a:r>
              <a:rPr lang="tr-TR" dirty="0" err="1"/>
              <a:t>miRNAs</a:t>
            </a:r>
            <a:r>
              <a:rPr lang="tr-TR" dirty="0"/>
              <a:t>' </a:t>
            </a:r>
            <a:r>
              <a:rPr lang="tr-TR" dirty="0" err="1"/>
              <a:t>sequences</a:t>
            </a:r>
            <a:r>
              <a:rPr lang="tr-TR" dirty="0"/>
              <a:t> </a:t>
            </a:r>
            <a:r>
              <a:rPr lang="tr-TR" dirty="0" err="1"/>
              <a:t>for</a:t>
            </a:r>
            <a:r>
              <a:rPr lang="tr-TR" dirty="0"/>
              <a:t> </a:t>
            </a:r>
            <a:r>
              <a:rPr lang="tr-TR" dirty="0" err="1"/>
              <a:t>determination</a:t>
            </a:r>
            <a:r>
              <a:rPr lang="tr-TR" dirty="0"/>
              <a:t> of </a:t>
            </a:r>
            <a:r>
              <a:rPr lang="tr-TR" dirty="0" err="1"/>
              <a:t>miRNA</a:t>
            </a:r>
            <a:r>
              <a:rPr lang="tr-TR" dirty="0"/>
              <a:t> </a:t>
            </a:r>
            <a:r>
              <a:rPr lang="tr-TR" dirty="0" err="1"/>
              <a:t>expression</a:t>
            </a:r>
            <a:r>
              <a:rPr lang="tr-TR" dirty="0"/>
              <a:t> </a:t>
            </a:r>
            <a:r>
              <a:rPr lang="tr-TR" dirty="0" err="1"/>
              <a:t>levels</a:t>
            </a:r>
            <a:r>
              <a:rPr lang="tr-TR" dirty="0"/>
              <a:t>.</a:t>
            </a:r>
          </a:p>
          <a:p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66FAFE-F996-4C83-9839-F2FB59A8BB69}" type="slidenum">
              <a:rPr lang="tr-TR" smtClean="0"/>
              <a:pPr/>
              <a:t>2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326264636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tr-TR" sz="12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Supplementary</a:t>
            </a:r>
            <a:r>
              <a:rPr lang="tr-T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tr-T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lustration of family pedigree of patient whose father sperm RNA was microinjected into mouse embryos </a:t>
            </a:r>
            <a:endParaRPr lang="tr-T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70AE13-12C4-4A49-84EF-FB392349FDC1}" type="slidenum">
              <a:rPr lang="tr-TR" smtClean="0"/>
              <a:pPr/>
              <a:t>3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39086399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tr-TR" sz="12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Supplementary</a:t>
            </a:r>
            <a:r>
              <a:rPr lang="tr-TR" sz="12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tr-T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tr-TR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perimental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sign and timeline as graphical abstract</a:t>
            </a:r>
            <a:endParaRPr lang="tr-T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66FAFE-F996-4C83-9839-F2FB59A8BB69}" type="slidenum">
              <a:rPr lang="tr-TR" smtClean="0"/>
              <a:pPr/>
              <a:t>4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73495574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b="1" dirty="0" err="1"/>
              <a:t>Supplementary</a:t>
            </a:r>
            <a:r>
              <a:rPr lang="tr-TR" b="1" dirty="0"/>
              <a:t> </a:t>
            </a:r>
            <a:r>
              <a:rPr lang="tr-TR" b="1" dirty="0" err="1"/>
              <a:t>Figure</a:t>
            </a:r>
            <a:r>
              <a:rPr lang="tr-TR" b="1" dirty="0"/>
              <a:t> 3. </a:t>
            </a:r>
            <a:r>
              <a:rPr lang="en-US" dirty="0"/>
              <a:t>Morphological examination of the hippocampus in the group injected with miR-499a-5p reverse microinjection.</a:t>
            </a:r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70AE13-12C4-4A49-84EF-FB392349FDC1}" type="slidenum">
              <a:rPr lang="tr-TR" smtClean="0"/>
              <a:pPr/>
              <a:t>5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208503490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15000"/>
              </a:lnSpc>
              <a:spcAft>
                <a:spcPts val="120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Supplementary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Figure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4: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of hippocampus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s belonging to the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erimental groups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A.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C</a:t>
            </a:r>
            <a:r>
              <a:rPr lang="en-US" sz="1800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ontrol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group,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B.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patient father sperm RNA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group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,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C.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miR-499a-5p </a:t>
            </a:r>
            <a:r>
              <a:rPr lang="tr-TR" sz="1800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reverse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group and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D.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F0 500 mg/kg VPA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group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.</a:t>
            </a:r>
          </a:p>
          <a:p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70AE13-12C4-4A49-84EF-FB392349FDC1}" type="slidenum">
              <a:rPr lang="tr-TR" smtClean="0"/>
              <a:pPr/>
              <a:t>6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120127876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15000"/>
              </a:lnSpc>
              <a:spcAft>
                <a:spcPts val="120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Supplementary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Figure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5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of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iatum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ppocampus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s belonging to the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0 %0.9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line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tr-TR" sz="1800" dirty="0">
              <a:solidFill>
                <a:srgbClr val="000000"/>
              </a:solidFill>
              <a:effectLst/>
              <a:latin typeface="Calibri Light" panose="020F0302020204030204" pitchFamily="34" charset="0"/>
              <a:ea typeface="Times New Roman" panose="02020603050405020304" pitchFamily="18" charset="0"/>
            </a:endParaRPr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70AE13-12C4-4A49-84EF-FB392349FDC1}" type="slidenum">
              <a:rPr lang="tr-TR" smtClean="0"/>
              <a:pPr/>
              <a:t>7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366875565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15000"/>
              </a:lnSpc>
              <a:spcAft>
                <a:spcPts val="120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Supplementary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Figure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6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of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iatum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s belonging to the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00 mg/kg VPA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erimental groups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.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A-B.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in different regions of the striatum tissue,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C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in the hippocampus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.</a:t>
            </a:r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70AE13-12C4-4A49-84EF-FB392349FDC1}" type="slidenum">
              <a:rPr lang="tr-TR" smtClean="0"/>
              <a:pPr/>
              <a:t>8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142964044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15000"/>
              </a:lnSpc>
              <a:spcAft>
                <a:spcPts val="120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Supplementary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Figure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7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of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iatum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ppocampus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in the group injected with 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400 mg/kg VPA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.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A.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of striatum tissue,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B.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 </a:t>
            </a:r>
            <a:r>
              <a:rPr lang="tr-TR" sz="1800" b="1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. </a:t>
            </a:r>
            <a:r>
              <a:rPr lang="tr-T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staining images </a:t>
            </a: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of hippocampus tissue</a:t>
            </a:r>
            <a:r>
              <a:rPr lang="tr-TR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.</a:t>
            </a:r>
          </a:p>
          <a:p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70AE13-12C4-4A49-84EF-FB392349FDC1}" type="slidenum">
              <a:rPr lang="tr-TR" smtClean="0"/>
              <a:pPr/>
              <a:t>9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3613288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xmlns="" id="{0A831912-86CD-4167-9B8C-6B8C29251B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Alt Başlık 2">
            <a:extLst>
              <a:ext uri="{FF2B5EF4-FFF2-40B4-BE49-F238E27FC236}">
                <a16:creationId xmlns:a16="http://schemas.microsoft.com/office/drawing/2014/main" xmlns="" id="{18AD0CF2-2D9E-4C20-A677-244833DD11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xmlns="" id="{8A578A84-DA67-4105-9E5B-10C29A7B5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3157D-58B7-4DF1-A8D4-84D9FF351EF0}" type="datetimeFigureOut">
              <a:rPr lang="tr-TR" smtClean="0"/>
              <a:pPr/>
              <a:t>8.01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xmlns="" id="{1E54C379-B4FE-4620-A8E7-AD78569524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xmlns="" id="{67FEFD0A-DA80-4631-8A78-F49AE90D2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39CDF-F3E5-4555-AB2E-45D75B185348}" type="slidenum">
              <a:rPr lang="tr-TR" smtClean="0"/>
              <a:pPr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2121334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xmlns="" id="{BC923C52-F1F9-4BC1-B188-BC644BA514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xmlns="" id="{74F309F1-B0F4-4EC2-BCD3-082F8E6BC0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xmlns="" id="{371BDDCD-101F-450A-B472-39222B331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3157D-58B7-4DF1-A8D4-84D9FF351EF0}" type="datetimeFigureOut">
              <a:rPr lang="tr-TR" smtClean="0"/>
              <a:pPr/>
              <a:t>8.01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xmlns="" id="{C95670B0-F6FE-4CA4-BC98-FEF4C4ECA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xmlns="" id="{8340074C-9565-4FEF-91A4-C74ED9C2B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39CDF-F3E5-4555-AB2E-45D75B185348}" type="slidenum">
              <a:rPr lang="tr-TR" smtClean="0"/>
              <a:pPr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1671088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>
            <a:extLst>
              <a:ext uri="{FF2B5EF4-FFF2-40B4-BE49-F238E27FC236}">
                <a16:creationId xmlns:a16="http://schemas.microsoft.com/office/drawing/2014/main" xmlns="" id="{CD28813A-C5ED-4465-AF12-6DE26971DF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xmlns="" id="{CB17A867-CA9F-4302-8666-5367021001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xmlns="" id="{89D6164A-6D30-41FE-B19E-E7AFEABEA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3157D-58B7-4DF1-A8D4-84D9FF351EF0}" type="datetimeFigureOut">
              <a:rPr lang="tr-TR" smtClean="0"/>
              <a:pPr/>
              <a:t>8.01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xmlns="" id="{D9658250-C8CC-448C-AE86-74C6073EC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xmlns="" id="{F85684C3-B27F-480A-A75C-25A6CAF018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39CDF-F3E5-4555-AB2E-45D75B185348}" type="slidenum">
              <a:rPr lang="tr-TR" smtClean="0"/>
              <a:pPr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2010399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xmlns="" id="{F7553910-088B-49AA-9C0C-6B9C10947B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xmlns="" id="{E3790A07-3507-409D-BA4B-4A74214643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xmlns="" id="{108145BD-35B1-4D86-9544-B87D306AF9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3157D-58B7-4DF1-A8D4-84D9FF351EF0}" type="datetimeFigureOut">
              <a:rPr lang="tr-TR" smtClean="0"/>
              <a:pPr/>
              <a:t>8.01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xmlns="" id="{AD101400-BD40-4109-AF8C-546B9F5681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xmlns="" id="{73D68B68-66F5-4C7A-8511-4163FAC99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39CDF-F3E5-4555-AB2E-45D75B185348}" type="slidenum">
              <a:rPr lang="tr-TR" smtClean="0"/>
              <a:pPr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4125469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xmlns="" id="{B5BFF8D8-3AD6-4BB7-A4D8-4B610CC398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xmlns="" id="{6886FE42-EAAA-4984-BDEF-24FF7E159F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xmlns="" id="{C96EF6AB-58D3-4C91-898C-CECF63B979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3157D-58B7-4DF1-A8D4-84D9FF351EF0}" type="datetimeFigureOut">
              <a:rPr lang="tr-TR" smtClean="0"/>
              <a:pPr/>
              <a:t>8.01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xmlns="" id="{A78468CE-0DDE-4DF9-A963-15D0D408F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xmlns="" id="{6EF3DE1B-BD3C-44BE-B19C-572AB9BD8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39CDF-F3E5-4555-AB2E-45D75B185348}" type="slidenum">
              <a:rPr lang="tr-TR" smtClean="0"/>
              <a:pPr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3377998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xmlns="" id="{40AFDD70-DDFD-4680-86F3-16558455E6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xmlns="" id="{D664EE8E-345D-4759-B1F6-5F6EC6602D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xmlns="" id="{E2D1F167-CDFA-4CFD-A65B-BB201592FC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xmlns="" id="{C7EE7407-D21E-4FA7-89AA-9C0EC3562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3157D-58B7-4DF1-A8D4-84D9FF351EF0}" type="datetimeFigureOut">
              <a:rPr lang="tr-TR" smtClean="0"/>
              <a:pPr/>
              <a:t>8.01.2024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xmlns="" id="{89B77074-6019-4F36-A5B5-226CD10EE9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xmlns="" id="{AE63BFEB-3A4D-4E63-8BCC-9D8971BFD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39CDF-F3E5-4555-AB2E-45D75B185348}" type="slidenum">
              <a:rPr lang="tr-TR" smtClean="0"/>
              <a:pPr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3239938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xmlns="" id="{A1ADA207-3776-4A92-8793-1AB7505968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xmlns="" id="{3C978C38-C091-45D7-9B45-89BCC1801B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xmlns="" id="{9B1F115D-0772-4D6E-94E5-74F39544A9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Metin Yer Tutucusu 4">
            <a:extLst>
              <a:ext uri="{FF2B5EF4-FFF2-40B4-BE49-F238E27FC236}">
                <a16:creationId xmlns:a16="http://schemas.microsoft.com/office/drawing/2014/main" xmlns="" id="{65DBB969-7AD5-4F91-B110-8BC621B604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İçerik Yer Tutucusu 5">
            <a:extLst>
              <a:ext uri="{FF2B5EF4-FFF2-40B4-BE49-F238E27FC236}">
                <a16:creationId xmlns:a16="http://schemas.microsoft.com/office/drawing/2014/main" xmlns="" id="{BA9DF66E-70E5-4C7B-BF08-A74BA82100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7" name="Veri Yer Tutucusu 6">
            <a:extLst>
              <a:ext uri="{FF2B5EF4-FFF2-40B4-BE49-F238E27FC236}">
                <a16:creationId xmlns:a16="http://schemas.microsoft.com/office/drawing/2014/main" xmlns="" id="{FE977292-1989-4160-9E0C-A79C1B3306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3157D-58B7-4DF1-A8D4-84D9FF351EF0}" type="datetimeFigureOut">
              <a:rPr lang="tr-TR" smtClean="0"/>
              <a:pPr/>
              <a:t>8.01.2024</a:t>
            </a:fld>
            <a:endParaRPr lang="tr-TR"/>
          </a:p>
        </p:txBody>
      </p:sp>
      <p:sp>
        <p:nvSpPr>
          <p:cNvPr id="8" name="Alt Bilgi Yer Tutucusu 7">
            <a:extLst>
              <a:ext uri="{FF2B5EF4-FFF2-40B4-BE49-F238E27FC236}">
                <a16:creationId xmlns:a16="http://schemas.microsoft.com/office/drawing/2014/main" xmlns="" id="{5CFB5B90-B634-40C5-A807-F7616AB32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9" name="Slayt Numarası Yer Tutucusu 8">
            <a:extLst>
              <a:ext uri="{FF2B5EF4-FFF2-40B4-BE49-F238E27FC236}">
                <a16:creationId xmlns:a16="http://schemas.microsoft.com/office/drawing/2014/main" xmlns="" id="{3964C703-9837-4433-95B9-3524C8C670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39CDF-F3E5-4555-AB2E-45D75B185348}" type="slidenum">
              <a:rPr lang="tr-TR" smtClean="0"/>
              <a:pPr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823990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xmlns="" id="{81846265-93E0-4658-8A27-5892537B0D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Veri Yer Tutucusu 2">
            <a:extLst>
              <a:ext uri="{FF2B5EF4-FFF2-40B4-BE49-F238E27FC236}">
                <a16:creationId xmlns:a16="http://schemas.microsoft.com/office/drawing/2014/main" xmlns="" id="{03F49202-9926-4525-9493-DC8F8B6DB2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3157D-58B7-4DF1-A8D4-84D9FF351EF0}" type="datetimeFigureOut">
              <a:rPr lang="tr-TR" smtClean="0"/>
              <a:pPr/>
              <a:t>8.01.2024</a:t>
            </a:fld>
            <a:endParaRPr lang="tr-TR"/>
          </a:p>
        </p:txBody>
      </p:sp>
      <p:sp>
        <p:nvSpPr>
          <p:cNvPr id="4" name="Alt Bilgi Yer Tutucusu 3">
            <a:extLst>
              <a:ext uri="{FF2B5EF4-FFF2-40B4-BE49-F238E27FC236}">
                <a16:creationId xmlns:a16="http://schemas.microsoft.com/office/drawing/2014/main" xmlns="" id="{60418F46-F2A2-4F70-843A-95CC61AD8B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5" name="Slayt Numarası Yer Tutucusu 4">
            <a:extLst>
              <a:ext uri="{FF2B5EF4-FFF2-40B4-BE49-F238E27FC236}">
                <a16:creationId xmlns:a16="http://schemas.microsoft.com/office/drawing/2014/main" xmlns="" id="{B6318BF9-0E79-426E-A7C6-030605535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39CDF-F3E5-4555-AB2E-45D75B185348}" type="slidenum">
              <a:rPr lang="tr-TR" smtClean="0"/>
              <a:pPr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3314621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>
            <a:extLst>
              <a:ext uri="{FF2B5EF4-FFF2-40B4-BE49-F238E27FC236}">
                <a16:creationId xmlns:a16="http://schemas.microsoft.com/office/drawing/2014/main" xmlns="" id="{C4B247C2-E646-42DF-A915-D3ABBB902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3157D-58B7-4DF1-A8D4-84D9FF351EF0}" type="datetimeFigureOut">
              <a:rPr lang="tr-TR" smtClean="0"/>
              <a:pPr/>
              <a:t>8.01.2024</a:t>
            </a:fld>
            <a:endParaRPr lang="tr-TR"/>
          </a:p>
        </p:txBody>
      </p:sp>
      <p:sp>
        <p:nvSpPr>
          <p:cNvPr id="3" name="Alt Bilgi Yer Tutucusu 2">
            <a:extLst>
              <a:ext uri="{FF2B5EF4-FFF2-40B4-BE49-F238E27FC236}">
                <a16:creationId xmlns:a16="http://schemas.microsoft.com/office/drawing/2014/main" xmlns="" id="{2DA3C0AB-C5D7-46A9-A852-C747383D0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4" name="Slayt Numarası Yer Tutucusu 3">
            <a:extLst>
              <a:ext uri="{FF2B5EF4-FFF2-40B4-BE49-F238E27FC236}">
                <a16:creationId xmlns:a16="http://schemas.microsoft.com/office/drawing/2014/main" xmlns="" id="{BB554078-05F5-44AE-A3B4-7749B731F8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39CDF-F3E5-4555-AB2E-45D75B185348}" type="slidenum">
              <a:rPr lang="tr-TR" smtClean="0"/>
              <a:pPr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3115494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xmlns="" id="{76290C32-4D24-4212-87FA-44C853732A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xmlns="" id="{A9E79268-7C8D-4FA4-B8D4-56D5FD349B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xmlns="" id="{32902360-2178-4B7D-BFCD-11C2B3BE0C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xmlns="" id="{27D9D028-1D32-4EC0-9131-66EB2B8C9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3157D-58B7-4DF1-A8D4-84D9FF351EF0}" type="datetimeFigureOut">
              <a:rPr lang="tr-TR" smtClean="0"/>
              <a:pPr/>
              <a:t>8.01.2024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xmlns="" id="{6CCF87C7-5FBF-4232-9F3E-76B548073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xmlns="" id="{2E93152E-D985-4145-A91D-7F084F873E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39CDF-F3E5-4555-AB2E-45D75B185348}" type="slidenum">
              <a:rPr lang="tr-TR" smtClean="0"/>
              <a:pPr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3790480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xmlns="" id="{27C5A924-1674-4E16-B7EA-9978745BD5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Resim Yer Tutucusu 2">
            <a:extLst>
              <a:ext uri="{FF2B5EF4-FFF2-40B4-BE49-F238E27FC236}">
                <a16:creationId xmlns:a16="http://schemas.microsoft.com/office/drawing/2014/main" xmlns="" id="{585672D3-3897-4B07-9C20-20790576BC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r-TR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xmlns="" id="{4B5A0C36-9BBD-46FE-BB82-E412B11BCD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xmlns="" id="{5FE7F1A2-A276-4A3E-BAD8-4105EADEA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3157D-58B7-4DF1-A8D4-84D9FF351EF0}" type="datetimeFigureOut">
              <a:rPr lang="tr-TR" smtClean="0"/>
              <a:pPr/>
              <a:t>8.01.2024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xmlns="" id="{A17CC6DC-BAE5-49E1-933F-A8B1FB302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xmlns="" id="{3C132BC5-4D6C-43C6-8862-2B7F607C0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39CDF-F3E5-4555-AB2E-45D75B185348}" type="slidenum">
              <a:rPr lang="tr-TR" smtClean="0"/>
              <a:pPr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3257415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>
            <a:extLst>
              <a:ext uri="{FF2B5EF4-FFF2-40B4-BE49-F238E27FC236}">
                <a16:creationId xmlns:a16="http://schemas.microsoft.com/office/drawing/2014/main" xmlns="" id="{004549A4-B03E-44A0-9624-494EE5F452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xmlns="" id="{EA2E9793-6F8C-4C20-ABDA-2CE3312BE5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xmlns="" id="{C3568AD6-3F03-4C69-855A-C7376DB3C7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C3157D-58B7-4DF1-A8D4-84D9FF351EF0}" type="datetimeFigureOut">
              <a:rPr lang="tr-TR" smtClean="0"/>
              <a:pPr/>
              <a:t>8.01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xmlns="" id="{71348991-FE72-4DF7-A286-6831127752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xmlns="" id="{0882F70E-8DB6-408C-A104-FA7E520F79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39CDF-F3E5-4555-AB2E-45D75B185348}" type="slidenum">
              <a:rPr lang="tr-TR" smtClean="0"/>
              <a:pPr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xmlns="" val="2942548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r-T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 4">
            <a:extLst>
              <a:ext uri="{FF2B5EF4-FFF2-40B4-BE49-F238E27FC236}">
                <a16:creationId xmlns:a16="http://schemas.microsoft.com/office/drawing/2014/main" xmlns="" id="{C8B69819-C794-4D1E-9885-6B2F7B5024F0}"/>
              </a:ext>
            </a:extLst>
          </p:cNvPr>
          <p:cNvGrpSpPr/>
          <p:nvPr/>
        </p:nvGrpSpPr>
        <p:grpSpPr>
          <a:xfrm>
            <a:off x="3850433" y="2341342"/>
            <a:ext cx="5469941" cy="1034546"/>
            <a:chOff x="3850433" y="2341342"/>
            <a:chExt cx="5469941" cy="1034546"/>
          </a:xfrm>
        </p:grpSpPr>
        <p:pic>
          <p:nvPicPr>
            <p:cNvPr id="3" name="Resim 2">
              <a:extLst>
                <a:ext uri="{FF2B5EF4-FFF2-40B4-BE49-F238E27FC236}">
                  <a16:creationId xmlns:a16="http://schemas.microsoft.com/office/drawing/2014/main" xmlns="" id="{B1A5AB62-2CBE-C053-D792-72A9C65280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/>
            <a:srcRect b="77162"/>
            <a:stretch/>
          </p:blipFill>
          <p:spPr>
            <a:xfrm>
              <a:off x="3850433" y="2341342"/>
              <a:ext cx="5469941" cy="369332"/>
            </a:xfrm>
            <a:prstGeom prst="rect">
              <a:avLst/>
            </a:prstGeom>
          </p:spPr>
        </p:pic>
        <p:pic>
          <p:nvPicPr>
            <p:cNvPr id="4" name="Resim 3">
              <a:extLst>
                <a:ext uri="{FF2B5EF4-FFF2-40B4-BE49-F238E27FC236}">
                  <a16:creationId xmlns:a16="http://schemas.microsoft.com/office/drawing/2014/main" xmlns="" id="{B3C1A2FE-7158-4F29-A470-E890E5168A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/>
            <a:srcRect t="58867"/>
            <a:stretch/>
          </p:blipFill>
          <p:spPr>
            <a:xfrm>
              <a:off x="3850433" y="2710674"/>
              <a:ext cx="5469941" cy="66521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xmlns="" val="39139174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Resim 3">
            <a:extLst>
              <a:ext uri="{FF2B5EF4-FFF2-40B4-BE49-F238E27FC236}">
                <a16:creationId xmlns:a16="http://schemas.microsoft.com/office/drawing/2014/main" xmlns="" id="{7C7A7A2F-56C7-A1D5-99B4-AC4E6993C08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6915" y="135923"/>
            <a:ext cx="10459323" cy="4955061"/>
          </a:xfrm>
          <a:prstGeom prst="rect">
            <a:avLst/>
          </a:prstGeom>
        </p:spPr>
      </p:pic>
      <p:sp>
        <p:nvSpPr>
          <p:cNvPr id="3" name="Metin kutusu 2">
            <a:extLst>
              <a:ext uri="{FF2B5EF4-FFF2-40B4-BE49-F238E27FC236}">
                <a16:creationId xmlns:a16="http://schemas.microsoft.com/office/drawing/2014/main" xmlns="" id="{F9F2EF19-7EE3-4099-AD9F-8D4340A306A2}"/>
              </a:ext>
            </a:extLst>
          </p:cNvPr>
          <p:cNvSpPr txBox="1"/>
          <p:nvPr/>
        </p:nvSpPr>
        <p:spPr>
          <a:xfrm>
            <a:off x="11055928" y="819399"/>
            <a:ext cx="676894" cy="4801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b="1" dirty="0"/>
              <a:t>(A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B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C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</p:txBody>
      </p:sp>
    </p:spTree>
    <p:extLst>
      <p:ext uri="{BB962C8B-B14F-4D97-AF65-F5344CB8AC3E}">
        <p14:creationId xmlns:p14="http://schemas.microsoft.com/office/powerpoint/2010/main" xmlns="" val="10544879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Resim 2">
            <a:extLst>
              <a:ext uri="{FF2B5EF4-FFF2-40B4-BE49-F238E27FC236}">
                <a16:creationId xmlns:a16="http://schemas.microsoft.com/office/drawing/2014/main" xmlns="" id="{710DE3D4-5737-5299-62D0-AC3494E3781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446666" y="0"/>
            <a:ext cx="9298668" cy="6858000"/>
          </a:xfrm>
          <a:prstGeom prst="rect">
            <a:avLst/>
          </a:prstGeom>
        </p:spPr>
      </p:pic>
      <p:sp>
        <p:nvSpPr>
          <p:cNvPr id="4" name="Metin kutusu 3">
            <a:extLst>
              <a:ext uri="{FF2B5EF4-FFF2-40B4-BE49-F238E27FC236}">
                <a16:creationId xmlns:a16="http://schemas.microsoft.com/office/drawing/2014/main" xmlns="" id="{B0317C5B-BFAC-49D7-B023-6B90A10FC81F}"/>
              </a:ext>
            </a:extLst>
          </p:cNvPr>
          <p:cNvSpPr txBox="1"/>
          <p:nvPr/>
        </p:nvSpPr>
        <p:spPr>
          <a:xfrm>
            <a:off x="11032176" y="1068780"/>
            <a:ext cx="676894" cy="53553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b="1" dirty="0"/>
              <a:t>(A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B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C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xmlns="" val="29532219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Resim 2">
            <a:extLst>
              <a:ext uri="{FF2B5EF4-FFF2-40B4-BE49-F238E27FC236}">
                <a16:creationId xmlns:a16="http://schemas.microsoft.com/office/drawing/2014/main" xmlns="" id="{8592F961-F3AC-6813-B7BB-7250760916E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062037" y="47625"/>
            <a:ext cx="10067925" cy="6762750"/>
          </a:xfrm>
          <a:prstGeom prst="rect">
            <a:avLst/>
          </a:prstGeom>
        </p:spPr>
      </p:pic>
      <p:sp>
        <p:nvSpPr>
          <p:cNvPr id="4" name="Metin kutusu 3">
            <a:extLst>
              <a:ext uri="{FF2B5EF4-FFF2-40B4-BE49-F238E27FC236}">
                <a16:creationId xmlns:a16="http://schemas.microsoft.com/office/drawing/2014/main" xmlns="" id="{1A799FEC-860B-4A0C-A1AE-D536B8335F1A}"/>
              </a:ext>
            </a:extLst>
          </p:cNvPr>
          <p:cNvSpPr txBox="1"/>
          <p:nvPr/>
        </p:nvSpPr>
        <p:spPr>
          <a:xfrm>
            <a:off x="11281559" y="1021279"/>
            <a:ext cx="676894" cy="53553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b="1" dirty="0"/>
              <a:t>(A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B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C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xmlns="" val="17771943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Resim 2">
            <a:extLst>
              <a:ext uri="{FF2B5EF4-FFF2-40B4-BE49-F238E27FC236}">
                <a16:creationId xmlns:a16="http://schemas.microsoft.com/office/drawing/2014/main" xmlns="" id="{1FA430FC-9C09-F492-4BE4-966699F665D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057275" y="183935"/>
            <a:ext cx="10077450" cy="3648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41520856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Resim 2">
            <a:extLst>
              <a:ext uri="{FF2B5EF4-FFF2-40B4-BE49-F238E27FC236}">
                <a16:creationId xmlns:a16="http://schemas.microsoft.com/office/drawing/2014/main" xmlns="" id="{7141A19E-1538-2603-2120-F707C42314C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42962" y="90487"/>
            <a:ext cx="10506075" cy="6677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050502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Resim 2">
            <a:extLst>
              <a:ext uri="{FF2B5EF4-FFF2-40B4-BE49-F238E27FC236}">
                <a16:creationId xmlns:a16="http://schemas.microsoft.com/office/drawing/2014/main" xmlns="" id="{F5458B8C-93F6-0A51-9D86-22EF90322F3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09999" y="95508"/>
            <a:ext cx="10401300" cy="3676650"/>
          </a:xfrm>
          <a:prstGeom prst="rect">
            <a:avLst/>
          </a:prstGeom>
        </p:spPr>
      </p:pic>
      <p:sp>
        <p:nvSpPr>
          <p:cNvPr id="4" name="Metin kutusu 3">
            <a:extLst>
              <a:ext uri="{FF2B5EF4-FFF2-40B4-BE49-F238E27FC236}">
                <a16:creationId xmlns:a16="http://schemas.microsoft.com/office/drawing/2014/main" xmlns="" id="{5EB20BA2-46EB-49BC-A453-E73DD7EEDE2F}"/>
              </a:ext>
            </a:extLst>
          </p:cNvPr>
          <p:cNvSpPr txBox="1"/>
          <p:nvPr/>
        </p:nvSpPr>
        <p:spPr>
          <a:xfrm>
            <a:off x="10937172" y="1068780"/>
            <a:ext cx="676894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b="1" dirty="0"/>
              <a:t>(A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B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</p:txBody>
      </p:sp>
    </p:spTree>
    <p:extLst>
      <p:ext uri="{BB962C8B-B14F-4D97-AF65-F5344CB8AC3E}">
        <p14:creationId xmlns:p14="http://schemas.microsoft.com/office/powerpoint/2010/main" xmlns="" val="6366895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o 11">
            <a:extLst>
              <a:ext uri="{FF2B5EF4-FFF2-40B4-BE49-F238E27FC236}">
                <a16:creationId xmlns:a16="http://schemas.microsoft.com/office/drawing/2014/main" xmlns="" id="{BF54E7C3-9BB8-4482-B903-3FA12E9DF12C}"/>
              </a:ext>
            </a:extLst>
          </p:cNvPr>
          <p:cNvGraphicFramePr>
            <a:graphicFrameLocks noGrp="1"/>
          </p:cNvGraphicFramePr>
          <p:nvPr/>
        </p:nvGraphicFramePr>
        <p:xfrm>
          <a:off x="2653260" y="1660734"/>
          <a:ext cx="6610662" cy="4635132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437594">
                  <a:extLst>
                    <a:ext uri="{9D8B030D-6E8A-4147-A177-3AD203B41FA5}">
                      <a16:colId xmlns:a16="http://schemas.microsoft.com/office/drawing/2014/main" xmlns="" val="3191248595"/>
                    </a:ext>
                  </a:extLst>
                </a:gridCol>
                <a:gridCol w="1252275">
                  <a:extLst>
                    <a:ext uri="{9D8B030D-6E8A-4147-A177-3AD203B41FA5}">
                      <a16:colId xmlns:a16="http://schemas.microsoft.com/office/drawing/2014/main" xmlns="" val="249016927"/>
                    </a:ext>
                  </a:extLst>
                </a:gridCol>
                <a:gridCol w="3920793">
                  <a:extLst>
                    <a:ext uri="{9D8B030D-6E8A-4147-A177-3AD203B41FA5}">
                      <a16:colId xmlns:a16="http://schemas.microsoft.com/office/drawing/2014/main" xmlns="" val="2264322655"/>
                    </a:ext>
                  </a:extLst>
                </a:gridCol>
              </a:tblGrid>
              <a:tr h="38626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NA</a:t>
                      </a:r>
                      <a:r>
                        <a:rPr lang="tr-TR" sz="1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ame</a:t>
                      </a:r>
                      <a:endParaRPr lang="tr-TR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rection</a:t>
                      </a:r>
                      <a:endParaRPr lang="tr-TR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  <a:endParaRPr lang="tr-TR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29284958"/>
                  </a:ext>
                </a:extLst>
              </a:tr>
              <a:tr h="3862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u-miR-19a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AGUUUUGCAUAGUUGCACUAC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34231850"/>
                  </a:ext>
                </a:extLst>
              </a:tr>
              <a:tr h="3862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GUGCAAAUCUAUGCAAAACUGA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96365412"/>
                  </a:ext>
                </a:extLst>
              </a:tr>
              <a:tr h="3862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u-miR-19b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UUUUGCAGGUUUGCAUCCAGC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71578698"/>
                  </a:ext>
                </a:extLst>
              </a:tr>
              <a:tr h="3862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GUGCAAAUCCAUGCAAAACUGA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933093"/>
                  </a:ext>
                </a:extLst>
              </a:tr>
              <a:tr h="3862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u-miR-499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UAAGACUUGCAGUGAUGUUU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40553756"/>
                  </a:ext>
                </a:extLst>
              </a:tr>
              <a:tr h="3862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CAUCACAGCAAGUCUGUGCU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18732894"/>
                  </a:ext>
                </a:extLst>
              </a:tr>
              <a:tr h="3862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u-miR-126a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UUAUUACUUUUGGUACGCG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88005732"/>
                  </a:ext>
                </a:extLst>
              </a:tr>
              <a:tr h="3862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CGUACCGUGAGUAAUAAUGCG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52359681"/>
                  </a:ext>
                </a:extLst>
              </a:tr>
              <a:tr h="3862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u-miR-361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UAUCAGAAUCUCCAGGGGUAC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3150457"/>
                  </a:ext>
                </a:extLst>
              </a:tr>
              <a:tr h="3862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CCCCCAGGUGUGAUUCUGAUUUGU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58679445"/>
                  </a:ext>
                </a:extLst>
              </a:tr>
              <a:tr h="38626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u-miR-150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CUCCCAACCCUUGUACCAGUG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271037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29241677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Resim 2">
            <a:extLst>
              <a:ext uri="{FF2B5EF4-FFF2-40B4-BE49-F238E27FC236}">
                <a16:creationId xmlns:a16="http://schemas.microsoft.com/office/drawing/2014/main" xmlns="" id="{2936314E-DBD1-46DF-24EF-3DFC7FA6E41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078028" y="152626"/>
            <a:ext cx="10531042" cy="61869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26994322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Resim 1">
            <a:extLst>
              <a:ext uri="{FF2B5EF4-FFF2-40B4-BE49-F238E27FC236}">
                <a16:creationId xmlns:a16="http://schemas.microsoft.com/office/drawing/2014/main" xmlns="" id="{AD471DDE-E8A2-6394-4961-F2D2318C3A1A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395869" y="360283"/>
            <a:ext cx="9400261" cy="61374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8003729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Resim 2">
            <a:extLst>
              <a:ext uri="{FF2B5EF4-FFF2-40B4-BE49-F238E27FC236}">
                <a16:creationId xmlns:a16="http://schemas.microsoft.com/office/drawing/2014/main" xmlns="" id="{1EB6E199-8255-2F4F-1242-68B23CA4E4C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752857" y="631867"/>
            <a:ext cx="8439150" cy="2505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4345079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Metin kutusu 2">
            <a:extLst>
              <a:ext uri="{FF2B5EF4-FFF2-40B4-BE49-F238E27FC236}">
                <a16:creationId xmlns:a16="http://schemas.microsoft.com/office/drawing/2014/main" xmlns="" id="{9E82EF33-6880-45F5-90F3-D7F2A6DD4673}"/>
              </a:ext>
            </a:extLst>
          </p:cNvPr>
          <p:cNvSpPr txBox="1"/>
          <p:nvPr/>
        </p:nvSpPr>
        <p:spPr>
          <a:xfrm>
            <a:off x="10794670" y="1056905"/>
            <a:ext cx="676894" cy="53553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b="1" dirty="0"/>
              <a:t>(A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B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C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D)</a:t>
            </a:r>
          </a:p>
        </p:txBody>
      </p:sp>
      <p:pic>
        <p:nvPicPr>
          <p:cNvPr id="2" name="Resim 1">
            <a:extLst>
              <a:ext uri="{FF2B5EF4-FFF2-40B4-BE49-F238E27FC236}">
                <a16:creationId xmlns:a16="http://schemas.microsoft.com/office/drawing/2014/main" xmlns="" id="{19E498D2-ADD7-406E-A7A6-13D911360A4E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42047" y="0"/>
            <a:ext cx="999538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5877861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Resim 2">
            <a:extLst>
              <a:ext uri="{FF2B5EF4-FFF2-40B4-BE49-F238E27FC236}">
                <a16:creationId xmlns:a16="http://schemas.microsoft.com/office/drawing/2014/main" xmlns="" id="{0C32CD51-41B8-65A6-D735-42BA58FDD7D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19312" y="1795462"/>
            <a:ext cx="7953375" cy="3267075"/>
          </a:xfrm>
          <a:prstGeom prst="rect">
            <a:avLst/>
          </a:prstGeom>
        </p:spPr>
      </p:pic>
      <p:sp>
        <p:nvSpPr>
          <p:cNvPr id="4" name="Metin kutusu 3">
            <a:extLst>
              <a:ext uri="{FF2B5EF4-FFF2-40B4-BE49-F238E27FC236}">
                <a16:creationId xmlns:a16="http://schemas.microsoft.com/office/drawing/2014/main" xmlns="" id="{C7306A90-C166-4732-A822-DB651323D4E8}"/>
              </a:ext>
            </a:extLst>
          </p:cNvPr>
          <p:cNvSpPr txBox="1"/>
          <p:nvPr/>
        </p:nvSpPr>
        <p:spPr>
          <a:xfrm>
            <a:off x="10604665" y="2755077"/>
            <a:ext cx="67689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b="1" dirty="0"/>
              <a:t>(A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xmlns="" val="21794740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Resim 3">
            <a:extLst>
              <a:ext uri="{FF2B5EF4-FFF2-40B4-BE49-F238E27FC236}">
                <a16:creationId xmlns:a16="http://schemas.microsoft.com/office/drawing/2014/main" xmlns="" id="{39966FA6-954C-672F-3E49-84B7CFAD232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124465" y="234242"/>
            <a:ext cx="7389340" cy="4757888"/>
          </a:xfrm>
          <a:prstGeom prst="rect">
            <a:avLst/>
          </a:prstGeom>
        </p:spPr>
      </p:pic>
      <p:sp>
        <p:nvSpPr>
          <p:cNvPr id="3" name="Metin kutusu 2">
            <a:extLst>
              <a:ext uri="{FF2B5EF4-FFF2-40B4-BE49-F238E27FC236}">
                <a16:creationId xmlns:a16="http://schemas.microsoft.com/office/drawing/2014/main" xmlns="" id="{0B5018F7-366C-4589-BFB7-35EFA34BBD2E}"/>
              </a:ext>
            </a:extLst>
          </p:cNvPr>
          <p:cNvSpPr txBox="1"/>
          <p:nvPr/>
        </p:nvSpPr>
        <p:spPr>
          <a:xfrm>
            <a:off x="8633361" y="950027"/>
            <a:ext cx="676894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b="1" dirty="0"/>
              <a:t>(A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B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xmlns="" val="670355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Resim 2">
            <a:extLst>
              <a:ext uri="{FF2B5EF4-FFF2-40B4-BE49-F238E27FC236}">
                <a16:creationId xmlns:a16="http://schemas.microsoft.com/office/drawing/2014/main" xmlns="" id="{38456556-BCEE-E956-641D-8065AAF848D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819275" y="387179"/>
            <a:ext cx="8553450" cy="3810000"/>
          </a:xfrm>
          <a:prstGeom prst="rect">
            <a:avLst/>
          </a:prstGeom>
        </p:spPr>
      </p:pic>
      <p:sp>
        <p:nvSpPr>
          <p:cNvPr id="4" name="Metin kutusu 3">
            <a:extLst>
              <a:ext uri="{FF2B5EF4-FFF2-40B4-BE49-F238E27FC236}">
                <a16:creationId xmlns:a16="http://schemas.microsoft.com/office/drawing/2014/main" xmlns="" id="{1BB32A3D-31A1-43E8-A498-425DDAC41D0E}"/>
              </a:ext>
            </a:extLst>
          </p:cNvPr>
          <p:cNvSpPr txBox="1"/>
          <p:nvPr/>
        </p:nvSpPr>
        <p:spPr>
          <a:xfrm>
            <a:off x="10782794" y="1365664"/>
            <a:ext cx="676894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b="1" dirty="0"/>
              <a:t>(A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r>
              <a:rPr lang="tr-TR" b="1" dirty="0"/>
              <a:t>(B)</a:t>
            </a:r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  <a:p>
            <a:endParaRPr lang="tr-TR" b="1" dirty="0"/>
          </a:p>
        </p:txBody>
      </p:sp>
    </p:spTree>
    <p:extLst>
      <p:ext uri="{BB962C8B-B14F-4D97-AF65-F5344CB8AC3E}">
        <p14:creationId xmlns:p14="http://schemas.microsoft.com/office/powerpoint/2010/main" xmlns="" val="9491720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637</Words>
  <Application>Microsoft Office PowerPoint</Application>
  <PresentationFormat>Custom</PresentationFormat>
  <Paragraphs>175</Paragraphs>
  <Slides>15</Slides>
  <Notes>1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6" baseType="lpstr">
      <vt:lpstr>Office Teması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unusu</dc:title>
  <dc:creator>Zeynep YILMAZ ŞÜKRANLI</dc:creator>
  <cp:lastModifiedBy>admin</cp:lastModifiedBy>
  <cp:revision>11</cp:revision>
  <dcterms:created xsi:type="dcterms:W3CDTF">2023-10-12T07:50:40Z</dcterms:created>
  <dcterms:modified xsi:type="dcterms:W3CDTF">2024-01-08T10:59:43Z</dcterms:modified>
</cp:coreProperties>
</file>